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7" r:id="rId2"/>
  </p:sldIdLst>
  <p:sldSz cx="7315200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" userDrawn="1">
          <p15:clr>
            <a:srgbClr val="A4A3A4"/>
          </p15:clr>
        </p15:guide>
        <p15:guide id="2" pos="1872" userDrawn="1">
          <p15:clr>
            <a:srgbClr val="A4A3A4"/>
          </p15:clr>
        </p15:guide>
        <p15:guide id="3" orient="horz" pos="672" userDrawn="1">
          <p15:clr>
            <a:srgbClr val="A4A3A4"/>
          </p15:clr>
        </p15:guide>
        <p15:guide id="4" orient="horz" pos="2136" userDrawn="1">
          <p15:clr>
            <a:srgbClr val="A4A3A4"/>
          </p15:clr>
        </p15:guide>
        <p15:guide id="5" pos="2064" userDrawn="1">
          <p15:clr>
            <a:srgbClr val="A4A3A4"/>
          </p15:clr>
        </p15:guide>
        <p15:guide id="6" pos="504" userDrawn="1">
          <p15:clr>
            <a:srgbClr val="A4A3A4"/>
          </p15:clr>
        </p15:guide>
        <p15:guide id="7" orient="horz" pos="13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B1C8"/>
    <a:srgbClr val="FF0000"/>
    <a:srgbClr val="7FD7F7"/>
    <a:srgbClr val="FF9999"/>
    <a:srgbClr val="6EBAD6"/>
    <a:srgbClr val="00B0F0"/>
    <a:srgbClr val="0066FF"/>
    <a:srgbClr val="660033"/>
    <a:srgbClr val="FFFFCC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2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96"/>
      </p:cViewPr>
      <p:guideLst>
        <p:guide orient="horz" pos="1440"/>
        <p:guide pos="1872"/>
        <p:guide orient="horz" pos="672"/>
        <p:guide orient="horz" pos="2136"/>
        <p:guide pos="2064"/>
        <p:guide pos="504"/>
        <p:guide orient="horz" pos="13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748242"/>
            <a:ext cx="5486400" cy="1591733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2401359"/>
            <a:ext cx="5486400" cy="1103841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31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6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243417"/>
            <a:ext cx="1577340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43417"/>
            <a:ext cx="4640580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18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699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139826"/>
            <a:ext cx="6309360" cy="1901825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3059642"/>
            <a:ext cx="6309360" cy="1000125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42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43417"/>
            <a:ext cx="6309360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1120775"/>
            <a:ext cx="3094672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670050"/>
            <a:ext cx="3094672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120775"/>
            <a:ext cx="3109913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670050"/>
            <a:ext cx="3109913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86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2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05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658284"/>
            <a:ext cx="3703320" cy="3249083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4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658284"/>
            <a:ext cx="3703320" cy="3249083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8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43417"/>
            <a:ext cx="6309360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217083"/>
            <a:ext cx="6309360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4237567"/>
            <a:ext cx="246888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2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18FA43F-CB04-4650-801A-E4C5E9232B60}"/>
              </a:ext>
            </a:extLst>
          </p:cNvPr>
          <p:cNvGrpSpPr/>
          <p:nvPr/>
        </p:nvGrpSpPr>
        <p:grpSpPr>
          <a:xfrm>
            <a:off x="1441174" y="796703"/>
            <a:ext cx="3841567" cy="2978593"/>
            <a:chOff x="3657600" y="1063403"/>
            <a:chExt cx="3841567" cy="2978593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CBEAD199-8F82-49D6-94A9-1F74C98AC7E2}"/>
                </a:ext>
              </a:extLst>
            </p:cNvPr>
            <p:cNvGrpSpPr/>
            <p:nvPr/>
          </p:nvGrpSpPr>
          <p:grpSpPr>
            <a:xfrm>
              <a:off x="3657600" y="1063403"/>
              <a:ext cx="3841567" cy="2978593"/>
              <a:chOff x="5695801" y="548245"/>
              <a:chExt cx="1936623" cy="1487961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19EE0346-D66E-46AE-91EC-8EB43B90D49D}"/>
                  </a:ext>
                </a:extLst>
              </p:cNvPr>
              <p:cNvGrpSpPr/>
              <p:nvPr/>
            </p:nvGrpSpPr>
            <p:grpSpPr>
              <a:xfrm>
                <a:off x="5695801" y="548245"/>
                <a:ext cx="1728914" cy="1404436"/>
                <a:chOff x="1995034" y="1715224"/>
                <a:chExt cx="2764435" cy="2401722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2DC8FEE4-7AFB-496C-913A-8A3A787EA1F0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1995034" y="1715224"/>
                  <a:ext cx="2764435" cy="2155218"/>
                  <a:chOff x="6764172" y="2204092"/>
                  <a:chExt cx="18503253" cy="14425591"/>
                </a:xfrm>
              </p:grpSpPr>
              <p:sp>
                <p:nvSpPr>
                  <p:cNvPr id="11" name="Oval 10">
                    <a:extLst>
                      <a:ext uri="{FF2B5EF4-FFF2-40B4-BE49-F238E27FC236}">
                        <a16:creationId xmlns:a16="http://schemas.microsoft.com/office/drawing/2014/main" id="{F4C42C43-78CC-4E8A-B214-1DAC6855906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764172" y="2204092"/>
                    <a:ext cx="13662119" cy="14425591"/>
                  </a:xfrm>
                  <a:prstGeom prst="ellipse">
                    <a:avLst/>
                  </a:prstGeom>
                  <a:solidFill>
                    <a:srgbClr val="FFC000">
                      <a:alpha val="4902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68634" tIns="34317" rIns="68634" bIns="34317" numCol="1" spcCol="0" rtlCol="0" fromWordArt="0" anchor="t" anchorCtr="0" forceAA="0" compatLnSpc="1">
                    <a:prstTxWarp prst="textNoShape">
                      <a:avLst/>
                    </a:prstTxWarp>
                    <a:noAutofit/>
                  </a:bodyPr>
                  <a:lstStyle>
                    <a:lvl1pPr marL="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l"/>
                    <a:endParaRPr lang="en-US" sz="853">
                      <a:latin typeface="Arial" panose="020B0604020202020204" pitchFamily="34" charset="0"/>
                      <a:ea typeface="Cambria" panose="02040503050406030204" pitchFamily="18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" name="Oval 11">
                    <a:extLst>
                      <a:ext uri="{FF2B5EF4-FFF2-40B4-BE49-F238E27FC236}">
                        <a16:creationId xmlns:a16="http://schemas.microsoft.com/office/drawing/2014/main" id="{1C72E2DA-60F8-4F84-9AC0-4AB9F07DA08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5381377" y="3955130"/>
                    <a:ext cx="9886048" cy="10902810"/>
                  </a:xfrm>
                  <a:prstGeom prst="ellipse">
                    <a:avLst/>
                  </a:prstGeom>
                  <a:solidFill>
                    <a:srgbClr val="6EBAD6">
                      <a:alpha val="49804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68634" tIns="34317" rIns="68634" bIns="34317" numCol="1" spcCol="0" rtlCol="0" fromWordArt="0" anchor="t" anchorCtr="0" forceAA="0" compatLnSpc="1">
                    <a:prstTxWarp prst="textNoShape">
                      <a:avLst/>
                    </a:prstTxWarp>
                    <a:noAutofit/>
                  </a:bodyPr>
                  <a:lstStyle>
                    <a:lvl1pPr marL="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l"/>
                    <a:endParaRPr lang="en-US" sz="853">
                      <a:latin typeface="Arial" panose="020B0604020202020204" pitchFamily="34" charset="0"/>
                      <a:ea typeface="Cambria" panose="02040503050406030204" pitchFamily="18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2F180BD1-2440-4B05-BF7D-0E8DDE9810FD}"/>
                    </a:ext>
                  </a:extLst>
                </p:cNvPr>
                <p:cNvSpPr txBox="1"/>
                <p:nvPr/>
              </p:nvSpPr>
              <p:spPr>
                <a:xfrm>
                  <a:off x="2066361" y="3854018"/>
                  <a:ext cx="1602962" cy="26292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b="1" dirty="0">
                      <a:solidFill>
                        <a:srgbClr val="FFC000"/>
                      </a:solidFill>
                      <a:latin typeface="Arial" panose="020B0604020202020204" pitchFamily="34" charset="0"/>
                      <a:ea typeface="Cambria" panose="02040503050406030204" pitchFamily="18" charset="0"/>
                      <a:cs typeface="Arial" panose="020B0604020202020204" pitchFamily="34" charset="0"/>
                    </a:rPr>
                    <a:t>Plasma exosomes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D362657F-F00A-46C3-92B4-D45C6B016E59}"/>
                    </a:ext>
                  </a:extLst>
                </p:cNvPr>
                <p:cNvSpPr txBox="1"/>
                <p:nvPr/>
              </p:nvSpPr>
              <p:spPr>
                <a:xfrm>
                  <a:off x="2366704" y="2569571"/>
                  <a:ext cx="588175" cy="32866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900" b="1" dirty="0">
                      <a:latin typeface="Arial" panose="020B0604020202020204" pitchFamily="34" charset="0"/>
                      <a:ea typeface="Cambria" panose="02040503050406030204" pitchFamily="18" charset="0"/>
                      <a:cs typeface="Arial" panose="020B0604020202020204" pitchFamily="34" charset="0"/>
                    </a:rPr>
                    <a:t>1449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27C80BE1-6F6D-47FC-87BA-C8D2B0381604}"/>
                    </a:ext>
                  </a:extLst>
                </p:cNvPr>
                <p:cNvSpPr txBox="1"/>
                <p:nvPr/>
              </p:nvSpPr>
              <p:spPr>
                <a:xfrm>
                  <a:off x="3414126" y="2571935"/>
                  <a:ext cx="478345" cy="3312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900" b="1" dirty="0">
                      <a:latin typeface="Arial" panose="020B0604020202020204" pitchFamily="34" charset="0"/>
                      <a:ea typeface="Cambria" panose="02040503050406030204" pitchFamily="18" charset="0"/>
                      <a:cs typeface="Arial" panose="020B0604020202020204" pitchFamily="34" charset="0"/>
                    </a:rPr>
                    <a:t>410</a:t>
                  </a:r>
                </a:p>
              </p:txBody>
            </p:sp>
          </p:grp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A7FAA41-07A8-4CFC-B1F0-69803C16D52A}"/>
                  </a:ext>
                </a:extLst>
              </p:cNvPr>
              <p:cNvSpPr txBox="1"/>
              <p:nvPr/>
            </p:nvSpPr>
            <p:spPr>
              <a:xfrm>
                <a:off x="6629911" y="1797893"/>
                <a:ext cx="1002513" cy="238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00B0F0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Urine exosomes</a:t>
                </a:r>
              </a:p>
              <a:p>
                <a:pPr algn="ctr"/>
                <a:r>
                  <a:rPr lang="en-US" sz="1100" dirty="0"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(Guan et al., 2020b)</a:t>
                </a: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E707AE2-7FCD-4AB2-AD24-2B76530F442C}"/>
                </a:ext>
              </a:extLst>
            </p:cNvPr>
            <p:cNvSpPr txBox="1"/>
            <p:nvPr/>
          </p:nvSpPr>
          <p:spPr>
            <a:xfrm>
              <a:off x="6346113" y="2068452"/>
              <a:ext cx="579838" cy="3877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900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611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69584486-AF7C-45C9-92C3-68511EF5CD34}"/>
              </a:ext>
            </a:extLst>
          </p:cNvPr>
          <p:cNvSpPr txBox="1"/>
          <p:nvPr/>
        </p:nvSpPr>
        <p:spPr>
          <a:xfrm>
            <a:off x="161925" y="143076"/>
            <a:ext cx="6934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: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enn diagram showing common and unique exosome proteins in plasma and urine samples 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5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1116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17</TotalTime>
  <Words>31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ip Patel</dc:creator>
  <cp:lastModifiedBy>Sandip</cp:lastModifiedBy>
  <cp:revision>245</cp:revision>
  <dcterms:created xsi:type="dcterms:W3CDTF">2020-03-03T17:34:57Z</dcterms:created>
  <dcterms:modified xsi:type="dcterms:W3CDTF">2020-12-25T06:17:46Z</dcterms:modified>
</cp:coreProperties>
</file>